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6" r:id="rId2"/>
  </p:sldIdLst>
  <p:sldSz cx="6858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05" autoAdjust="0"/>
    <p:restoredTop sz="94660"/>
  </p:normalViewPr>
  <p:slideViewPr>
    <p:cSldViewPr snapToGrid="0">
      <p:cViewPr>
        <p:scale>
          <a:sx n="189" d="100"/>
          <a:sy n="189" d="100"/>
        </p:scale>
        <p:origin x="-138" y="-24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9F2912-6A67-4913-9B89-415456E0F93E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57450" y="1241425"/>
            <a:ext cx="188277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9C80A9-FAEA-4751-98D1-C075D12516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733572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86192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020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27651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2301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43333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3034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1765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9107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20905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750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88336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807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419947" y="1715186"/>
            <a:ext cx="11196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err="1"/>
              <a:t>Brachypodium</a:t>
            </a:r>
            <a:r>
              <a:rPr lang="en-AU" sz="1200" dirty="0"/>
              <a:t> </a:t>
            </a:r>
          </a:p>
          <a:p>
            <a:r>
              <a:rPr lang="en-AU" sz="1200" dirty="0"/>
              <a:t>       gene</a:t>
            </a:r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4350323"/>
              </p:ext>
            </p:extLst>
          </p:nvPr>
        </p:nvGraphicFramePr>
        <p:xfrm>
          <a:off x="1091507" y="2220877"/>
          <a:ext cx="4479521" cy="11620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97503"/>
                <a:gridCol w="1611770"/>
                <a:gridCol w="1170248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BRADI4G24367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TraesCS4A01G20640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499354181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BRADI4G2432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TraesCS4A01G20660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500113138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BRADI4G2431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TraesCS4A01G20670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50013880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BRADI4G2428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TraesCS4A01G20700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500352424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BRADI4G2427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TraesCS4A01G20720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500431374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BRADI4G2426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TraesCS4A01G20730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00629685</a:t>
                      </a:r>
                      <a:endParaRPr lang="en-AU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2875627" y="1759212"/>
            <a:ext cx="13502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Wheat homologue</a:t>
            </a:r>
            <a:endParaRPr lang="en-AU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4432965" y="1759212"/>
            <a:ext cx="11822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Wheat genome </a:t>
            </a:r>
          </a:p>
          <a:p>
            <a:r>
              <a:rPr lang="en-AU" sz="1200" dirty="0"/>
              <a:t> </a:t>
            </a:r>
            <a:r>
              <a:rPr lang="en-AU" sz="1200" dirty="0" smtClean="0"/>
              <a:t>  co-ordinate</a:t>
            </a:r>
            <a:endParaRPr lang="en-AU" sz="1200" dirty="0"/>
          </a:p>
        </p:txBody>
      </p:sp>
      <p:cxnSp>
        <p:nvCxnSpPr>
          <p:cNvPr id="12" name="Straight Connector 11"/>
          <p:cNvCxnSpPr/>
          <p:nvPr/>
        </p:nvCxnSpPr>
        <p:spPr>
          <a:xfrm>
            <a:off x="1419947" y="2176851"/>
            <a:ext cx="401314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1419947" y="1205214"/>
            <a:ext cx="14000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 smtClean="0"/>
              <a:t>Chromosome 4A</a:t>
            </a:r>
            <a:endParaRPr lang="en-AU" sz="1400" dirty="0"/>
          </a:p>
        </p:txBody>
      </p:sp>
      <p:graphicFrame>
        <p:nvGraphicFramePr>
          <p:cNvPr id="14" name="Tab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4530311"/>
              </p:ext>
            </p:extLst>
          </p:nvPr>
        </p:nvGraphicFramePr>
        <p:xfrm>
          <a:off x="1067710" y="5042166"/>
          <a:ext cx="4471987" cy="134683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71439"/>
                <a:gridCol w="1693665"/>
                <a:gridCol w="1106883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RADI4G24367</a:t>
                      </a:r>
                      <a:endParaRPr lang="en-AU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TraesCS4B01G10990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122563187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BRADI4G2436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TraesCS4B01G11000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122853544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BRADI4G2432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TraesCS4B01G11010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123449152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BRADI4G2431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TraesCS4B01G11020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123497048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BRADI4G2428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TraesCS4B01G11060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124020646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BRADI4G2427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TraesCS4B01G11070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124460303</a:t>
                      </a:r>
                      <a:endParaRPr lang="en-AU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solidFill>
                            <a:schemeClr val="tx1"/>
                          </a:solidFill>
                          <a:effectLst/>
                        </a:rPr>
                        <a:t>BRADI4G24260</a:t>
                      </a:r>
                      <a:endParaRPr lang="en-AU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>
                          <a:solidFill>
                            <a:schemeClr val="tx1"/>
                          </a:solidFill>
                          <a:effectLst/>
                        </a:rPr>
                        <a:t>TraesCS4B01G110800</a:t>
                      </a:r>
                      <a:endParaRPr lang="en-AU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24496735</a:t>
                      </a:r>
                      <a:endParaRPr lang="en-AU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</a:tbl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1435071" y="4498077"/>
            <a:ext cx="11196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err="1"/>
              <a:t>Brachypodium</a:t>
            </a:r>
            <a:r>
              <a:rPr lang="en-AU" sz="1200" dirty="0"/>
              <a:t> </a:t>
            </a:r>
          </a:p>
          <a:p>
            <a:r>
              <a:rPr lang="en-AU" sz="1200" dirty="0"/>
              <a:t>       gene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890751" y="4542103"/>
            <a:ext cx="13502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Wheat homologue</a:t>
            </a:r>
            <a:endParaRPr lang="en-AU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4448089" y="4542103"/>
            <a:ext cx="11822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Wheat genome </a:t>
            </a:r>
          </a:p>
          <a:p>
            <a:r>
              <a:rPr lang="en-AU" sz="1200" dirty="0"/>
              <a:t> </a:t>
            </a:r>
            <a:r>
              <a:rPr lang="en-AU" sz="1200" dirty="0" smtClean="0"/>
              <a:t>  co-ordinate</a:t>
            </a:r>
            <a:endParaRPr lang="en-AU" sz="1200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1435071" y="4959742"/>
            <a:ext cx="401314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1435071" y="3988105"/>
            <a:ext cx="13936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 smtClean="0"/>
              <a:t>Chromosome 4B</a:t>
            </a:r>
            <a:endParaRPr lang="en-AU" sz="1400" dirty="0"/>
          </a:p>
        </p:txBody>
      </p:sp>
      <p:graphicFrame>
        <p:nvGraphicFramePr>
          <p:cNvPr id="21" name="Table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1990984"/>
              </p:ext>
            </p:extLst>
          </p:nvPr>
        </p:nvGraphicFramePr>
        <p:xfrm>
          <a:off x="1219351" y="8048240"/>
          <a:ext cx="4184679" cy="174688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39411"/>
                <a:gridCol w="1869749"/>
                <a:gridCol w="875519"/>
              </a:tblGrid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200" u="none" strike="noStrike">
                          <a:effectLst/>
                        </a:rPr>
                        <a:t>BRADI4G2436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TraesCS4D01G107400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8559093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BRADI4G24360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TraesCS4D01G105200LC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8568022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BRADI4G24350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TraesCS4D01G107700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85745229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BRADI4G24320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TraesCS4D01G107800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8587751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BRADI4G24310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TraesCS4D01G106100LC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8599639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BRADI4G24310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TraesCS4D01G108000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8754508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BRADI4G24280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TraesCS4D01G108300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8771702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BRADI4G24270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TraesCS4D01G108400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8772772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BRADI4G24260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>
                          <a:effectLst/>
                        </a:rPr>
                        <a:t>TraesCS4D01G108500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>
                          <a:effectLst/>
                        </a:rPr>
                        <a:t>87945502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</a:tbl>
          </a:graphicData>
        </a:graphic>
      </p:graphicFrame>
      <p:sp>
        <p:nvSpPr>
          <p:cNvPr id="22" name="TextBox 21"/>
          <p:cNvSpPr txBox="1"/>
          <p:nvPr/>
        </p:nvSpPr>
        <p:spPr>
          <a:xfrm>
            <a:off x="1375763" y="7451196"/>
            <a:ext cx="11196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err="1"/>
              <a:t>Brachypodium</a:t>
            </a:r>
            <a:r>
              <a:rPr lang="en-AU" sz="1200" dirty="0"/>
              <a:t> </a:t>
            </a:r>
          </a:p>
          <a:p>
            <a:r>
              <a:rPr lang="en-AU" sz="1200" dirty="0"/>
              <a:t>       gene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831443" y="7495222"/>
            <a:ext cx="13502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Wheat homologue</a:t>
            </a:r>
            <a:endParaRPr lang="en-AU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4388781" y="7495222"/>
            <a:ext cx="11822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Wheat genome </a:t>
            </a:r>
          </a:p>
          <a:p>
            <a:r>
              <a:rPr lang="en-AU" sz="1200" dirty="0"/>
              <a:t> </a:t>
            </a:r>
            <a:r>
              <a:rPr lang="en-AU" sz="1200" dirty="0" smtClean="0"/>
              <a:t>  co-ordinate</a:t>
            </a:r>
            <a:endParaRPr lang="en-AU" sz="1200" dirty="0"/>
          </a:p>
        </p:txBody>
      </p:sp>
      <p:cxnSp>
        <p:nvCxnSpPr>
          <p:cNvPr id="25" name="Straight Connector 24"/>
          <p:cNvCxnSpPr/>
          <p:nvPr/>
        </p:nvCxnSpPr>
        <p:spPr>
          <a:xfrm>
            <a:off x="1375763" y="7912861"/>
            <a:ext cx="401314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1375763" y="6941224"/>
            <a:ext cx="14064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 smtClean="0"/>
              <a:t>Chromosome 4D</a:t>
            </a:r>
            <a:endParaRPr lang="en-AU" sz="1400" dirty="0"/>
          </a:p>
        </p:txBody>
      </p:sp>
      <p:sp>
        <p:nvSpPr>
          <p:cNvPr id="27" name="TextBox 26"/>
          <p:cNvSpPr txBox="1"/>
          <p:nvPr/>
        </p:nvSpPr>
        <p:spPr>
          <a:xfrm>
            <a:off x="164029" y="114764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l Figure </a:t>
            </a:r>
            <a:r>
              <a:rPr lang="en-AU" b="1" dirty="0"/>
              <a:t>7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48764" y="10516243"/>
            <a:ext cx="56039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/>
              <a:t>Figure S7</a:t>
            </a:r>
            <a:r>
              <a:rPr lang="en-AU" sz="1200" dirty="0" smtClean="0"/>
              <a:t>: Location of co-linear wheat sequences with homology to </a:t>
            </a:r>
            <a:r>
              <a:rPr lang="en-AU" sz="1200" dirty="0" err="1" smtClean="0"/>
              <a:t>Brachypodium</a:t>
            </a:r>
            <a:r>
              <a:rPr lang="en-AU" sz="1200" dirty="0" smtClean="0"/>
              <a:t> genes present at the </a:t>
            </a:r>
            <a:r>
              <a:rPr lang="en-AU" sz="1200" i="1" dirty="0" smtClean="0"/>
              <a:t>Yrr1</a:t>
            </a:r>
            <a:r>
              <a:rPr lang="en-AU" sz="1200" dirty="0" smtClean="0"/>
              <a:t> locus. Note that there are many other genes in this region not shown that do not fit with this cross species gene co-linearity.</a:t>
            </a:r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22913677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84</TotalTime>
  <Words>144</Words>
  <Application>Microsoft Office PowerPoint</Application>
  <PresentationFormat>Widescreen</PresentationFormat>
  <Paragraphs>8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 Unicode MS</vt:lpstr>
      <vt:lpstr>Arial</vt:lpstr>
      <vt:lpstr>Calibri</vt:lpstr>
      <vt:lpstr>Calibri Light</vt:lpstr>
      <vt:lpstr>Office Theme</vt:lpstr>
      <vt:lpstr>PowerPoint Presentation</vt:lpstr>
    </vt:vector>
  </TitlesOfParts>
  <Company>CSIR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liffe, Michael (Agriculture, Crace)</dc:creator>
  <cp:lastModifiedBy>Ayliffe, Michael (Agriculture, Crace)</cp:lastModifiedBy>
  <cp:revision>447</cp:revision>
  <cp:lastPrinted>2018-07-12T02:44:08Z</cp:lastPrinted>
  <dcterms:created xsi:type="dcterms:W3CDTF">2016-09-08T23:56:59Z</dcterms:created>
  <dcterms:modified xsi:type="dcterms:W3CDTF">2018-08-23T00:50:01Z</dcterms:modified>
</cp:coreProperties>
</file>